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D92DE6-6B74-44BF-8CCD-E49F3ED09F0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D60698-9A14-4DD1-9086-1B25B130D0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7038B1-273C-4034-AD1D-048328B2B4F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B1EC61-8CEC-499F-A929-8E6CFF16C75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EA15C0-C8EA-4A56-A9FC-132458D0A2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9544F9-02A3-417D-99F1-8901ABB2FC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349726-D0D0-44A1-BC19-39F880B1AF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346647-8C78-4C48-99A2-E2A19AD0FB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77B39B-1248-4D4E-A212-87A6BA7E2D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ECD497-2975-44CB-B2B7-B3761BCA0F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D2A647-2531-4119-BAB0-33A2552859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CB710A-9018-4564-99C6-B9FBE943A6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C6C25F-86C2-4BD7-9258-99D35FEDD5C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3.wmf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4.wmf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5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Data from autonomic function test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468360" y="-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Nitroprusside-50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  <a:ea typeface="Arial"/>
              </a:rPr>
              <a:t>µ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4" name=""/>
          <p:cNvGraphicFramePr/>
          <p:nvPr/>
        </p:nvGraphicFramePr>
        <p:xfrm>
          <a:off x="1692360" y="1197000"/>
          <a:ext cx="5956200" cy="51339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5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692360" y="1197000"/>
                    <a:ext cx="5956200" cy="5133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6" name=""/>
          <p:cNvSpPr/>
          <p:nvPr/>
        </p:nvSpPr>
        <p:spPr>
          <a:xfrm>
            <a:off x="5724360" y="2349360"/>
            <a:ext cx="0" cy="432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5559480" y="2516040"/>
            <a:ext cx="18396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5539680" y="1484280"/>
            <a:ext cx="16804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Verdana"/>
              </a:rPr>
              <a:t>3min-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Verdana"/>
              </a:rPr>
              <a:t>absence of HR respon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187280" y="6237360"/>
            <a:ext cx="741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Absence of response of increase HR to drop in blood pressur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94360" y="1647720"/>
            <a:ext cx="1005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mmHg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275640" y="981000"/>
            <a:ext cx="1332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50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µ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 IV blou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708360" y="1557360"/>
            <a:ext cx="0" cy="647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Phenylephrine-50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  <a:ea typeface="Arial"/>
              </a:rPr>
              <a:t>µ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4" name=""/>
          <p:cNvGraphicFramePr/>
          <p:nvPr/>
        </p:nvGraphicFramePr>
        <p:xfrm>
          <a:off x="1403280" y="1700280"/>
          <a:ext cx="7056360" cy="41050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55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403280" y="1700280"/>
                    <a:ext cx="7056360" cy="4105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6" name=""/>
          <p:cNvSpPr/>
          <p:nvPr/>
        </p:nvSpPr>
        <p:spPr>
          <a:xfrm flipH="1">
            <a:off x="6443280" y="2349360"/>
            <a:ext cx="360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6829560" y="2178000"/>
            <a:ext cx="7840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Verdana"/>
              </a:rPr>
              <a:t>S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Verdana"/>
              </a:rPr>
              <a:t>Increa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Verdana"/>
              </a:rPr>
              <a:t>25 mmH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026800" y="6180120"/>
            <a:ext cx="568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Absence of decrease HR in response to elevated B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564000" y="1916280"/>
            <a:ext cx="0" cy="5047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184560" y="1433520"/>
            <a:ext cx="226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henylephrine 50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µ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 IV bolu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521280" y="1936800"/>
            <a:ext cx="1005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mmHg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ental Arithmetic with Serial 7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3" name=""/>
          <p:cNvGraphicFramePr/>
          <p:nvPr/>
        </p:nvGraphicFramePr>
        <p:xfrm>
          <a:off x="1979640" y="1628640"/>
          <a:ext cx="6192720" cy="40323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6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979640" y="1628640"/>
                    <a:ext cx="6192720" cy="4032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5" name=""/>
          <p:cNvSpPr/>
          <p:nvPr/>
        </p:nvSpPr>
        <p:spPr>
          <a:xfrm flipV="1">
            <a:off x="6372360" y="3141720"/>
            <a:ext cx="0" cy="7207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5775480" y="4413240"/>
            <a:ext cx="18396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5754960" y="3357720"/>
            <a:ext cx="5374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Verdana"/>
              </a:rPr>
              <a:t>60se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Verdana"/>
              </a:rPr>
              <a:t>After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Verdana"/>
              </a:rPr>
              <a:t>tes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flipH="1">
            <a:off x="6659640" y="2708280"/>
            <a:ext cx="5047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293480" y="5892840"/>
            <a:ext cx="5118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Verdana"/>
              </a:rPr>
              <a:t>Significant rise in DBP in response to stres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4140360" y="1773360"/>
            <a:ext cx="0" cy="431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924720" y="1413000"/>
            <a:ext cx="51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ta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4400" spc="-1" strike="noStrike">
                <a:solidFill>
                  <a:srgbClr val="000000"/>
                </a:solidFill>
                <a:latin typeface="Arial"/>
              </a:rPr>
              <a:t>Atropine 2mg (0.04/mg/kg blous)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3" name=""/>
          <p:cNvGraphicFramePr/>
          <p:nvPr/>
        </p:nvGraphicFramePr>
        <p:xfrm>
          <a:off x="495360" y="1619280"/>
          <a:ext cx="7859520" cy="41814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7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95360" y="1619280"/>
                    <a:ext cx="7859520" cy="4181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5" name=""/>
          <p:cNvSpPr/>
          <p:nvPr/>
        </p:nvSpPr>
        <p:spPr>
          <a:xfrm>
            <a:off x="887760" y="5805360"/>
            <a:ext cx="76957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High resting H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Small increase in HR only after atropin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Consistent with substantial parasympathetic denervation of the heart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2627280" y="1628640"/>
            <a:ext cx="0" cy="576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557800" y="1341360"/>
            <a:ext cx="80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tropi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title"/>
          </p:nvPr>
        </p:nvSpPr>
        <p:spPr>
          <a:xfrm>
            <a:off x="468360" y="-1717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4000" spc="-1" strike="noStrike">
                <a:solidFill>
                  <a:srgbClr val="000000"/>
                </a:solidFill>
                <a:latin typeface="Arial"/>
              </a:rPr>
              <a:t>Inderal (1mg/min infusion)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9" name=""/>
          <p:cNvGraphicFramePr/>
          <p:nvPr/>
        </p:nvGraphicFramePr>
        <p:xfrm>
          <a:off x="539640" y="585720"/>
          <a:ext cx="8112240" cy="62722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80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39640" y="585720"/>
                    <a:ext cx="8112240" cy="627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1" name=""/>
          <p:cNvSpPr/>
          <p:nvPr/>
        </p:nvSpPr>
        <p:spPr>
          <a:xfrm>
            <a:off x="2556000" y="1484280"/>
            <a:ext cx="0" cy="503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341440" y="907920"/>
            <a:ext cx="47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ta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7003080" y="4745160"/>
            <a:ext cx="8146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im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min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613440" y="1916280"/>
            <a:ext cx="1005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mmHg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1-14T03:51:25Z</dcterms:created>
  <dc:creator>NTEC</dc:creator>
  <dc:description/>
  <dc:language>en-US</dc:language>
  <cp:lastModifiedBy>Ronald Ma</cp:lastModifiedBy>
  <dcterms:modified xsi:type="dcterms:W3CDTF">2007-01-20T09:29:34Z</dcterms:modified>
  <cp:revision>8</cp:revision>
  <dc:subject/>
  <dc:title>Test graph for baroreceptor</dc:title>
</cp:coreProperties>
</file>